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72" y="-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15574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2324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0776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68383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71581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87344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88565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86558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34203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3057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85154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175568-E23D-460A-863C-59AFB9A34DE6}" type="datetimeFigureOut">
              <a:rPr lang="en-ZA" smtClean="0"/>
              <a:t>2021/09/1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B00C9-16A4-4A01-85CA-1BA2B0602EB3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06887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7142372"/>
              </p:ext>
            </p:extLst>
          </p:nvPr>
        </p:nvGraphicFramePr>
        <p:xfrm>
          <a:off x="2170430" y="2164874"/>
          <a:ext cx="7531100" cy="1859280"/>
        </p:xfrm>
        <a:graphic>
          <a:graphicData uri="http://schemas.openxmlformats.org/drawingml/2006/table">
            <a:tbl>
              <a:tblPr/>
              <a:tblGrid>
                <a:gridCol w="2894380">
                  <a:extLst>
                    <a:ext uri="{9D8B030D-6E8A-4147-A177-3AD203B41FA5}">
                      <a16:colId xmlns:a16="http://schemas.microsoft.com/office/drawing/2014/main" val="2129039894"/>
                    </a:ext>
                  </a:extLst>
                </a:gridCol>
                <a:gridCol w="2837254">
                  <a:extLst>
                    <a:ext uri="{9D8B030D-6E8A-4147-A177-3AD203B41FA5}">
                      <a16:colId xmlns:a16="http://schemas.microsoft.com/office/drawing/2014/main" val="2656822365"/>
                    </a:ext>
                  </a:extLst>
                </a:gridCol>
                <a:gridCol w="1799466">
                  <a:extLst>
                    <a:ext uri="{9D8B030D-6E8A-4147-A177-3AD203B41FA5}">
                      <a16:colId xmlns:a16="http://schemas.microsoft.com/office/drawing/2014/main" val="4178247922"/>
                    </a:ext>
                  </a:extLst>
                </a:gridCol>
              </a:tblGrid>
              <a:tr h="175260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Supplementary Table S1. </a:t>
                      </a:r>
                      <a:r>
                        <a:rPr lang="en-US" sz="1000" b="1" i="0" u="none" strike="noStrike" dirty="0" err="1">
                          <a:effectLst/>
                          <a:latin typeface="Arial" panose="020B0604020202020204" pitchFamily="34" charset="0"/>
                        </a:rPr>
                        <a:t>FastANI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 estimated Average Nucleotide </a:t>
                      </a:r>
                      <a:r>
                        <a:rPr lang="en-US" sz="1000" b="1" i="0" u="none" strike="noStrike" dirty="0" err="1">
                          <a:effectLst/>
                          <a:latin typeface="Arial" panose="020B0604020202020204" pitchFamily="34" charset="0"/>
                        </a:rPr>
                        <a:t>Identinty</a:t>
                      </a:r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 (ANI) of a selected Enterobacter specie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27535122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 dirty="0">
                          <a:effectLst/>
                          <a:latin typeface="Arial" panose="020B0604020202020204" pitchFamily="34" charset="0"/>
                        </a:rPr>
                        <a:t>Query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Referenc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ANI Estimat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7448708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S4SPAdes.contig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hormaechei_subsp._hoffmanni.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99.0027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0921683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S5SPAdes.contig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hormaechei_subsp._hoffmanni.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98.984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6500848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S4SPAdes.contig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S5SPAdes.contig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99.9088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8803338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hormaechei_subsp_ohara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hormaechei_subsp_steigerwaltii.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97.5421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7400902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hormaechei_subsp_ohara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robacter_xiangfangensis.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97.1322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7884522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hormaechei_subsp_steigerwaltii.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robacter_xiangfangensi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97.0515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6174431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cloacae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cloacae_subsp.dissolvens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95.3593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8977211"/>
                  </a:ext>
                </a:extLst>
              </a:tr>
              <a:tr h="175260"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hormaechei_subsp._hoffmanni.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Enterobacter_hormaechei_subsp_hormaechei.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000" b="0" i="0" u="none" strike="noStrike">
                          <a:effectLst/>
                          <a:latin typeface="Arial" panose="020B0604020202020204" pitchFamily="34" charset="0"/>
                        </a:rPr>
                        <a:t>94.554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9813658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l" fontAlgn="b"/>
                      <a:endParaRPr lang="en-ZA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ZA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1364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22601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6513485"/>
              </p:ext>
            </p:extLst>
          </p:nvPr>
        </p:nvGraphicFramePr>
        <p:xfrm>
          <a:off x="1123406" y="815042"/>
          <a:ext cx="9866811" cy="5550922"/>
        </p:xfrm>
        <a:graphic>
          <a:graphicData uri="http://schemas.openxmlformats.org/drawingml/2006/table">
            <a:tbl>
              <a:tblPr/>
              <a:tblGrid>
                <a:gridCol w="3500845">
                  <a:extLst>
                    <a:ext uri="{9D8B030D-6E8A-4147-A177-3AD203B41FA5}">
                      <a16:colId xmlns:a16="http://schemas.microsoft.com/office/drawing/2014/main" val="3558663073"/>
                    </a:ext>
                  </a:extLst>
                </a:gridCol>
                <a:gridCol w="2804160">
                  <a:extLst>
                    <a:ext uri="{9D8B030D-6E8A-4147-A177-3AD203B41FA5}">
                      <a16:colId xmlns:a16="http://schemas.microsoft.com/office/drawing/2014/main" val="3291586339"/>
                    </a:ext>
                  </a:extLst>
                </a:gridCol>
                <a:gridCol w="2255520">
                  <a:extLst>
                    <a:ext uri="{9D8B030D-6E8A-4147-A177-3AD203B41FA5}">
                      <a16:colId xmlns:a16="http://schemas.microsoft.com/office/drawing/2014/main" val="4236636232"/>
                    </a:ext>
                  </a:extLst>
                </a:gridCol>
                <a:gridCol w="653143">
                  <a:extLst>
                    <a:ext uri="{9D8B030D-6E8A-4147-A177-3AD203B41FA5}">
                      <a16:colId xmlns:a16="http://schemas.microsoft.com/office/drawing/2014/main" val="3749388429"/>
                    </a:ext>
                  </a:extLst>
                </a:gridCol>
                <a:gridCol w="498204">
                  <a:extLst>
                    <a:ext uri="{9D8B030D-6E8A-4147-A177-3AD203B41FA5}">
                      <a16:colId xmlns:a16="http://schemas.microsoft.com/office/drawing/2014/main" val="806558076"/>
                    </a:ext>
                  </a:extLst>
                </a:gridCol>
                <a:gridCol w="154939">
                  <a:extLst>
                    <a:ext uri="{9D8B030D-6E8A-4147-A177-3AD203B41FA5}">
                      <a16:colId xmlns:a16="http://schemas.microsoft.com/office/drawing/2014/main" val="925111786"/>
                    </a:ext>
                  </a:extLst>
                </a:gridCol>
              </a:tblGrid>
              <a:tr h="124361">
                <a:tc gridSpan="6"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effectLst/>
                          <a:latin typeface="Arial" panose="020B0604020202020204" pitchFamily="34" charset="0"/>
                        </a:rPr>
                        <a:t>Supplementary Table S2. Antimicrobial Resistance Determinants detected in the genomes of the isolates S4 and S5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Z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0352659"/>
                  </a:ext>
                </a:extLst>
              </a:tr>
              <a:tr h="121871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MR Gene Family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RO Term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Resistance Mechanism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600" b="0" i="0" u="none" strike="noStrike" dirty="0">
                          <a:effectLst/>
                          <a:latin typeface="Arial" panose="020B0604020202020204" pitchFamily="34" charset="0"/>
                        </a:rPr>
                        <a:t>S4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600" b="0" i="0" u="none" strike="noStrike" dirty="0">
                          <a:effectLst/>
                          <a:latin typeface="Arial" panose="020B0604020202020204" pitchFamily="34" charset="0"/>
                        </a:rPr>
                        <a:t>S5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8789818"/>
                  </a:ext>
                </a:extLst>
              </a:tr>
              <a:tr h="32982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resistance-nodulation-cell division (RND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 err="1">
                          <a:effectLst/>
                          <a:latin typeface="Arial" panose="020B0604020202020204" pitchFamily="34" charset="0"/>
                        </a:rPr>
                        <a:t>adeF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9803959"/>
                  </a:ext>
                </a:extLst>
              </a:tr>
              <a:tr h="32982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resistance-nodulation-cell division (RND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CR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5722303"/>
                  </a:ext>
                </a:extLst>
              </a:tr>
              <a:tr h="221687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major facilitator superfamily (MFS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Klebsiella pneumoniae KpnE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763953"/>
                  </a:ext>
                </a:extLst>
              </a:tr>
              <a:tr h="221687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major facilitator superfamily (MFS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Klebsiella pneumoniae KpnF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7890121"/>
                  </a:ext>
                </a:extLst>
              </a:tr>
              <a:tr h="32982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resistance-nodulation-cell division (RND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oqxA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5553327"/>
                  </a:ext>
                </a:extLst>
              </a:tr>
              <a:tr h="32982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resistance-nodulation-cell division (RND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rsmA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7149325"/>
                  </a:ext>
                </a:extLst>
              </a:tr>
              <a:tr h="221687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major facilitator superfamily (MFS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emrB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1199705"/>
                  </a:ext>
                </a:extLst>
              </a:tr>
              <a:tr h="221687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major facilitator superfamily (MFS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emrR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9186337"/>
                  </a:ext>
                </a:extLst>
              </a:tr>
              <a:tr h="546105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resistance-nodulation-cell division (RND) antibiotic efflux pump, General Bacterial Porin with reduced permeability to beta-lactams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marA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, reduced permeability to antibiotic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1263577"/>
                  </a:ext>
                </a:extLst>
              </a:tr>
              <a:tr h="546105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major facilitator superfamily (MFS) antibiotic efflux pump, resistance-nodulation-cell division (RND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H-NS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922435"/>
                  </a:ext>
                </a:extLst>
              </a:tr>
              <a:tr h="32982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resistance-nodulation-cell division (RND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baeR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8726849"/>
                  </a:ext>
                </a:extLst>
              </a:tr>
              <a:tr h="22168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mpC-type beta-lactamase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Escherichia coli ampH beta-lactamase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inactivation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3543148"/>
                  </a:ext>
                </a:extLst>
              </a:tr>
              <a:tr h="121871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fosfomycin thiol transferase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FosA2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inactivation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0691980"/>
                  </a:ext>
                </a:extLst>
              </a:tr>
              <a:tr h="121871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CT beta-lactamase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CT-23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inactivation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9076378"/>
                  </a:ext>
                </a:extLst>
              </a:tr>
              <a:tr h="22168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TP-binding cassette (ABC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msbA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6609254"/>
                  </a:ext>
                </a:extLst>
              </a:tr>
              <a:tr h="329827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Penicillin-binding protein mutations conferring resistance to beta-lactam antibiotics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Haemophilus influenzae PBP3 conferring resistance to beta-lactam antibiotics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target alteration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6920288"/>
                  </a:ext>
                </a:extLst>
              </a:tr>
              <a:tr h="32982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-resistant UhpT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Escherichia coli UhpT with mutation conferring resistance to fosfomycin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antibiotic target alteration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ZA" sz="6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6574121"/>
                  </a:ext>
                </a:extLst>
              </a:tr>
              <a:tr h="329827"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resistance-nodulation-cell division (RND) antibiotic efflux pump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>
                          <a:effectLst/>
                          <a:latin typeface="Arial" panose="020B0604020202020204" pitchFamily="34" charset="0"/>
                        </a:rPr>
                        <a:t>Escherichia coli marR mutant conferring antibiotic resistance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effectLst/>
                          <a:latin typeface="Arial" panose="020B0604020202020204" pitchFamily="34" charset="0"/>
                        </a:rPr>
                        <a:t>antibiotic target alteration, antibiotic efflux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W" sz="600" b="0" i="0" u="none" strike="noStrike" dirty="0">
                          <a:effectLst/>
                          <a:latin typeface="Arial" panose="020B0604020202020204" pitchFamily="34" charset="0"/>
                        </a:rPr>
                        <a:t>+</a:t>
                      </a:r>
                      <a:endParaRPr lang="en-ZA" sz="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ZA" sz="600" b="0" i="0" u="none" strike="noStrike" dirty="0"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245" marR="4245" marT="42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8796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81547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5</TotalTime>
  <Words>419</Words>
  <Application>Microsoft Office PowerPoint</Application>
  <PresentationFormat>Widescreen</PresentationFormat>
  <Paragraphs>12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WUUSER</dc:creator>
  <cp:lastModifiedBy>MDPI</cp:lastModifiedBy>
  <cp:revision>43</cp:revision>
  <dcterms:created xsi:type="dcterms:W3CDTF">2020-12-10T10:04:47Z</dcterms:created>
  <dcterms:modified xsi:type="dcterms:W3CDTF">2021-09-11T05:39:12Z</dcterms:modified>
</cp:coreProperties>
</file>